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  <p:sldId id="262" r:id="rId5"/>
    <p:sldId id="263" r:id="rId6"/>
    <p:sldId id="264" r:id="rId7"/>
    <p:sldId id="25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581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52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974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189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803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031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607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1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319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789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129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964C5-FF41-481F-9E1D-D6E7A6CE0B7C}" type="datetimeFigureOut">
              <a:rPr lang="en-US" smtClean="0"/>
              <a:t>4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7C92C-DD2A-4FCE-9E63-77F589784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9980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62974" y="1483744"/>
            <a:ext cx="9523562" cy="2026220"/>
          </a:xfrm>
        </p:spPr>
        <p:txBody>
          <a:bodyPr>
            <a:noAutofit/>
          </a:bodyPr>
          <a:lstStyle/>
          <a:p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S1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GSEA of 247 genes linked by GREAT with 351 human-specific LTR7 and LTR5_Hs using the Enrichr bioinformatics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platform (A; F)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and targeted interrogations of 17 (B; C) human-specific LTR7 and LTR5_Hs loci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14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(D; E)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human-specific LTR7 and LTR5_Hs loci employing the GREAT algorithm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- E). </a:t>
            </a:r>
            <a:b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Related to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Inference of putative phenotypic impacts of human-specific LTR7 &amp; LTR5_Hs loci based on GREAT algorithm-guided functional annotations of proximity placement-linked </a:t>
            </a:r>
            <a:r>
              <a:rPr lang="en-US" sz="1800" dirty="0" smtClean="0">
                <a:latin typeface="Arial" panose="020B0604020202020204" pitchFamily="34" charset="0"/>
                <a:cs typeface="Arial" panose="020B0604020202020204" pitchFamily="34" charset="0"/>
              </a:rPr>
              <a:t>genes. </a:t>
            </a:r>
            <a:endParaRPr 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600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s://appyters.maayanlab.cloud/Enrichment_Analysis_Visualizer/52f280c9f0e6869d03202aaa6640a47f2c87a70f/Enrichr_results_bar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7375" y="1216316"/>
            <a:ext cx="6453557" cy="3581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0932" y="664227"/>
            <a:ext cx="5203533" cy="58102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950899" y="17896"/>
            <a:ext cx="398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351 human-specific LTR7 &amp; LTR5_Hs loci</a:t>
            </a:r>
          </a:p>
          <a:p>
            <a:pPr algn="ctr"/>
            <a:r>
              <a:rPr lang="en-US" b="1" dirty="0" smtClean="0"/>
              <a:t>247 genes</a:t>
            </a:r>
            <a:endParaRPr lang="en-US" b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779452" y="6284927"/>
            <a:ext cx="455943" cy="1466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413783" y="6105145"/>
            <a:ext cx="3886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aïve Primed Pluripotent States Genes</a:t>
            </a:r>
            <a:endParaRPr lang="en-US" b="1" dirty="0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8100402" y="2096219"/>
            <a:ext cx="1078103" cy="2021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9437297" y="2096219"/>
            <a:ext cx="542406" cy="0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0201661" y="2096219"/>
            <a:ext cx="296685" cy="0"/>
          </a:xfrm>
          <a:prstGeom prst="line">
            <a:avLst/>
          </a:prstGeom>
          <a:ln w="508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2"/>
          <p:cNvSpPr txBox="1"/>
          <p:nvPr/>
        </p:nvSpPr>
        <p:spPr>
          <a:xfrm>
            <a:off x="20129" y="8955"/>
            <a:ext cx="359434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0249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5920" y="207034"/>
            <a:ext cx="10036201" cy="35319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86597" y="207034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7 human-specific LTR7 &amp; LTR5_Hs loci</a:t>
            </a:r>
            <a:endParaRPr lang="en-US" b="1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5919" y="3826878"/>
            <a:ext cx="10036201" cy="269556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86193" y="3826878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7 human-specific LTR7 &amp; LTR5_Hs loci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0363829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209692" y="94891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7 human-specific LTR7 &amp; LTR5_Hs loci</a:t>
            </a:r>
            <a:endParaRPr lang="en-US" b="1" dirty="0"/>
          </a:p>
        </p:txBody>
      </p:sp>
      <p:sp>
        <p:nvSpPr>
          <p:cNvPr id="6" name="TextBox 3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2988" y="561050"/>
            <a:ext cx="5676001" cy="596226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31079" y="561049"/>
            <a:ext cx="3317903" cy="59622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028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5921" y="207034"/>
            <a:ext cx="10036201" cy="35319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5921" y="3826878"/>
            <a:ext cx="10036201" cy="2849967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86597" y="207034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4 human-specific LTR7 &amp; LTR5_Hs loci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86193" y="3826878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4 human-specific LTR7 &amp; LTR5_Hs loci</a:t>
            </a:r>
            <a:endParaRPr lang="en-US" b="1" dirty="0"/>
          </a:p>
        </p:txBody>
      </p:sp>
      <p:sp>
        <p:nvSpPr>
          <p:cNvPr id="6" name="TextBox 3"/>
          <p:cNvSpPr txBox="1"/>
          <p:nvPr/>
        </p:nvSpPr>
        <p:spPr>
          <a:xfrm>
            <a:off x="0" y="0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2784848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2403" y="561050"/>
            <a:ext cx="5369605" cy="596177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44154" y="561049"/>
            <a:ext cx="3112653" cy="596226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209692" y="94891"/>
            <a:ext cx="386336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14 human-specific LTR7 &amp; LTR5_Hs loci</a:t>
            </a:r>
            <a:endParaRPr lang="en-US" b="1" dirty="0"/>
          </a:p>
        </p:txBody>
      </p:sp>
      <p:sp>
        <p:nvSpPr>
          <p:cNvPr id="6" name="TextBox 3"/>
          <p:cNvSpPr txBox="1"/>
          <p:nvPr/>
        </p:nvSpPr>
        <p:spPr>
          <a:xfrm>
            <a:off x="0" y="0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0929689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4842" y="664227"/>
            <a:ext cx="4981575" cy="581025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50899" y="17896"/>
            <a:ext cx="39803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351 human-specific LTR7 &amp; LTR5_Hs loci</a:t>
            </a:r>
          </a:p>
          <a:p>
            <a:pPr algn="ctr"/>
            <a:r>
              <a:rPr lang="en-US" b="1" dirty="0" smtClean="0"/>
              <a:t>215 LTR-regulated genes</a:t>
            </a:r>
            <a:endParaRPr lang="en-US" b="1" dirty="0"/>
          </a:p>
        </p:txBody>
      </p:sp>
      <p:pic>
        <p:nvPicPr>
          <p:cNvPr id="1026" name="Picture 2" descr="https://appyters.maayanlab.cloud/Enrichment_Analysis_Visualizer/cd1540d6afb7c2308bd9166651ea45467aaf1f6d/Enrichr_results_ba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091" y="1376950"/>
            <a:ext cx="6132751" cy="45600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3"/>
          <p:cNvSpPr txBox="1"/>
          <p:nvPr/>
        </p:nvSpPr>
        <p:spPr>
          <a:xfrm>
            <a:off x="0" y="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271068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27</Words>
  <Application>Microsoft Office PowerPoint</Application>
  <PresentationFormat>Widescreen</PresentationFormat>
  <Paragraphs>18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Supplemental Figure S1. GSEA of 247 genes linked by GREAT with 351 human-specific LTR7 and LTR5_Hs using the Enrichr bioinformatics platform (A; F) and targeted interrogations of 17 (B; C) human-specific LTR7 and LTR5_Hs loci and 14 (D; E) human-specific LTR7 and LTR5_Hs loci employing the GREAT algorithm (B - E).  Related to Figure 5. Inference of putative phenotypic impacts of human-specific LTR7 &amp; LTR5_Hs loci based on GREAT algorithm-guided functional annotations of proximity placement-linked genes.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S1. </dc:title>
  <dc:creator>Guennadi Glinskii</dc:creator>
  <cp:lastModifiedBy>Guennadi Glinskii</cp:lastModifiedBy>
  <cp:revision>12</cp:revision>
  <dcterms:created xsi:type="dcterms:W3CDTF">2022-03-24T07:48:42Z</dcterms:created>
  <dcterms:modified xsi:type="dcterms:W3CDTF">2022-04-09T07:08:43Z</dcterms:modified>
</cp:coreProperties>
</file>